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sldIdLst>
    <p:sldId id="270" r:id="rId2"/>
    <p:sldId id="266" r:id="rId3"/>
    <p:sldId id="267" r:id="rId4"/>
    <p:sldId id="271" r:id="rId5"/>
    <p:sldId id="273" r:id="rId6"/>
    <p:sldId id="275" r:id="rId7"/>
    <p:sldId id="278" r:id="rId8"/>
    <p:sldId id="277" r:id="rId9"/>
    <p:sldId id="272" r:id="rId10"/>
    <p:sldId id="276" r:id="rId11"/>
    <p:sldId id="269" r:id="rId12"/>
    <p:sldId id="274" r:id="rId1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830" autoAdjust="0"/>
    <p:restoredTop sz="94682"/>
  </p:normalViewPr>
  <p:slideViewPr>
    <p:cSldViewPr snapToGrid="0">
      <p:cViewPr varScale="1">
        <p:scale>
          <a:sx n="88" d="100"/>
          <a:sy n="88" d="100"/>
        </p:scale>
        <p:origin x="13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EB9A9E-81FA-45DC-934C-3D4E9C32783E}" type="datetimeFigureOut">
              <a:rPr lang="zh-CN" altLang="en-US" smtClean="0"/>
              <a:t>2018/4/2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70BD09-9B7A-41DC-ACB5-52C64AA735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80635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470BD09-9B7A-41DC-ACB5-52C64AA735F9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729789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470BD09-9B7A-41DC-ACB5-52C64AA735F9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971076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69D325C-39FA-412B-8C90-170FCA054897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31710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42137-F398-49BF-85C6-89508C934DBC}" type="datetimeFigureOut">
              <a:rPr lang="zh-CN" altLang="en-US" smtClean="0"/>
              <a:t>2018/4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190E5-1D24-4811-BA49-306386EAED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37385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42137-F398-49BF-85C6-89508C934DBC}" type="datetimeFigureOut">
              <a:rPr lang="zh-CN" altLang="en-US" smtClean="0"/>
              <a:t>2018/4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190E5-1D24-4811-BA49-306386EAED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45028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42137-F398-49BF-85C6-89508C934DBC}" type="datetimeFigureOut">
              <a:rPr lang="zh-CN" altLang="en-US" smtClean="0"/>
              <a:t>2018/4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190E5-1D24-4811-BA49-306386EAED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09874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42137-F398-49BF-85C6-89508C934DBC}" type="datetimeFigureOut">
              <a:rPr lang="zh-CN" altLang="en-US" smtClean="0"/>
              <a:t>2018/4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190E5-1D24-4811-BA49-306386EAED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05168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42137-F398-49BF-85C6-89508C934DBC}" type="datetimeFigureOut">
              <a:rPr lang="zh-CN" altLang="en-US" smtClean="0"/>
              <a:t>2018/4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190E5-1D24-4811-BA49-306386EAED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70833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42137-F398-49BF-85C6-89508C934DBC}" type="datetimeFigureOut">
              <a:rPr lang="zh-CN" altLang="en-US" smtClean="0"/>
              <a:t>2018/4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190E5-1D24-4811-BA49-306386EAED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02571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42137-F398-49BF-85C6-89508C934DBC}" type="datetimeFigureOut">
              <a:rPr lang="zh-CN" altLang="en-US" smtClean="0"/>
              <a:t>2018/4/2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190E5-1D24-4811-BA49-306386EAED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04755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42137-F398-49BF-85C6-89508C934DBC}" type="datetimeFigureOut">
              <a:rPr lang="zh-CN" altLang="en-US" smtClean="0"/>
              <a:t>2018/4/2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190E5-1D24-4811-BA49-306386EAED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584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42137-F398-49BF-85C6-89508C934DBC}" type="datetimeFigureOut">
              <a:rPr lang="zh-CN" altLang="en-US" smtClean="0"/>
              <a:t>2018/4/2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190E5-1D24-4811-BA49-306386EAED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87929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42137-F398-49BF-85C6-89508C934DBC}" type="datetimeFigureOut">
              <a:rPr lang="zh-CN" altLang="en-US" smtClean="0"/>
              <a:t>2018/4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190E5-1D24-4811-BA49-306386EAED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57682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42137-F398-49BF-85C6-89508C934DBC}" type="datetimeFigureOut">
              <a:rPr lang="zh-CN" altLang="en-US" smtClean="0"/>
              <a:t>2018/4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190E5-1D24-4811-BA49-306386EAED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73344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542137-F398-49BF-85C6-89508C934DBC}" type="datetimeFigureOut">
              <a:rPr lang="zh-CN" altLang="en-US" smtClean="0"/>
              <a:t>2018/4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6190E5-1D24-4811-BA49-306386EAED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98084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696684" y="1242422"/>
            <a:ext cx="10428515" cy="527836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zh-CN" sz="2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</a:t>
            </a:r>
            <a:r>
              <a:rPr lang="en-US" altLang="zh-CN" sz="20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les </a:t>
            </a:r>
            <a:r>
              <a:rPr lang="en-US" altLang="zh-CN" sz="2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:Supplementary </a:t>
            </a:r>
            <a:r>
              <a:rPr lang="en-US" altLang="zh-CN" sz="20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s and Tables</a:t>
            </a:r>
            <a:endParaRPr lang="zh-CN" altLang="zh-CN" sz="140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. 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dependent deletion confirms male fertility increase due to </a:t>
            </a:r>
            <a:r>
              <a:rPr lang="en-US" altLang="zh-CN" i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r-977</a:t>
            </a:r>
            <a:r>
              <a:rPr lang="en-US" altLang="zh-CN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letion.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zh-CN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. Lifecycle of new gene.</a:t>
            </a:r>
            <a:endParaRPr lang="zh-CN" altLang="zh-CN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. </a:t>
            </a:r>
            <a:r>
              <a:rPr lang="en-US" altLang="zh-CN" i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-977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in 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osophila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ecies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algn="just">
              <a:lnSpc>
                <a:spcPct val="150000"/>
              </a:lnSpc>
            </a:pP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2. Expression variation of </a:t>
            </a:r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-977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testes across 5 lines of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melanogaster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altLang="zh-CN" kern="1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e fertility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zh-CN" i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-977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O.</a:t>
            </a:r>
          </a:p>
          <a:p>
            <a:pPr algn="just">
              <a:lnSpc>
                <a:spcPct val="150000"/>
              </a:lnSpc>
            </a:pP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.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imulating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ulation and sperm quality of </a:t>
            </a:r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-977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KO.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.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iotic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ive of </a:t>
            </a:r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-977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KO.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6.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ability of </a:t>
            </a:r>
            <a:r>
              <a:rPr lang="en-US" altLang="zh-CN" i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-977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KO.</a:t>
            </a:r>
            <a:endParaRPr lang="en-US" altLang="zh-CN" kern="1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7.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ting success of </a:t>
            </a:r>
            <a:r>
              <a:rPr lang="en-US" altLang="zh-CN" i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-977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O.</a:t>
            </a:r>
            <a:endParaRPr lang="zh-CN" altLang="zh-CN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8.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s used in this study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>
              <a:lnSpc>
                <a:spcPct val="150000"/>
              </a:lnSpc>
            </a:pP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9.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LEN pairs design for </a:t>
            </a:r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-977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2" name="矩形 1"/>
          <p:cNvSpPr/>
          <p:nvPr/>
        </p:nvSpPr>
        <p:spPr>
          <a:xfrm>
            <a:off x="696684" y="183607"/>
            <a:ext cx="996043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zh-CN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n the possibility of death of new genes – Evidence from the deletion of </a:t>
            </a:r>
            <a:r>
              <a:rPr lang="en-US" altLang="zh-CN" b="1" i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 novo</a:t>
            </a:r>
            <a:r>
              <a:rPr lang="en-US" altLang="zh-CN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b="1" kern="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croRNAs</a:t>
            </a:r>
          </a:p>
          <a:p>
            <a:pPr>
              <a:lnSpc>
                <a:spcPct val="200000"/>
              </a:lnSpc>
            </a:pPr>
            <a:r>
              <a:rPr lang="en-US" altLang="zh-CN" b="1" kern="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 err="1"/>
              <a:t>Guang</a:t>
            </a:r>
            <a:r>
              <a:rPr lang="en-US" altLang="zh-CN" sz="1600" dirty="0"/>
              <a:t>-An </a:t>
            </a:r>
            <a:r>
              <a:rPr lang="en-US" altLang="zh-CN" sz="1600" dirty="0" smtClean="0"/>
              <a:t>Lu, </a:t>
            </a:r>
            <a:r>
              <a:rPr lang="en-US" altLang="zh-CN" sz="1600" dirty="0" err="1"/>
              <a:t>Yixin</a:t>
            </a:r>
            <a:r>
              <a:rPr lang="en-US" altLang="zh-CN" sz="1600" dirty="0"/>
              <a:t> </a:t>
            </a:r>
            <a:r>
              <a:rPr lang="en-US" altLang="zh-CN" sz="1600" dirty="0" smtClean="0"/>
              <a:t>Zhao, </a:t>
            </a:r>
            <a:r>
              <a:rPr lang="en-US" altLang="zh-CN" sz="1600" dirty="0" err="1"/>
              <a:t>Zhongqi</a:t>
            </a:r>
            <a:r>
              <a:rPr lang="en-US" altLang="zh-CN" sz="1600" dirty="0"/>
              <a:t> </a:t>
            </a:r>
            <a:r>
              <a:rPr lang="en-US" altLang="zh-CN" sz="1600" dirty="0" err="1"/>
              <a:t>Liufu</a:t>
            </a:r>
            <a:r>
              <a:rPr lang="en-US" altLang="zh-CN" sz="1600" dirty="0"/>
              <a:t> </a:t>
            </a:r>
            <a:r>
              <a:rPr lang="en-US" altLang="zh-CN" sz="1600" dirty="0" smtClean="0"/>
              <a:t>, </a:t>
            </a:r>
            <a:r>
              <a:rPr lang="en-US" altLang="zh-CN" sz="1600" dirty="0"/>
              <a:t>Chung-I </a:t>
            </a:r>
            <a:r>
              <a:rPr lang="en-US" altLang="zh-CN" sz="1600" dirty="0" smtClean="0"/>
              <a:t>Wu</a:t>
            </a:r>
            <a:endParaRPr lang="zh-CN" altLang="zh-CN" sz="1600" dirty="0"/>
          </a:p>
        </p:txBody>
      </p:sp>
    </p:spTree>
    <p:extLst>
      <p:ext uri="{BB962C8B-B14F-4D97-AF65-F5344CB8AC3E}">
        <p14:creationId xmlns:p14="http://schemas.microsoft.com/office/powerpoint/2010/main" val="83926642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188325" y="791178"/>
            <a:ext cx="41133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7.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ting succes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-977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O.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00445416"/>
              </p:ext>
            </p:extLst>
          </p:nvPr>
        </p:nvGraphicFramePr>
        <p:xfrm>
          <a:off x="351403" y="1269339"/>
          <a:ext cx="8095849" cy="259588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322959"/>
                <a:gridCol w="1898199"/>
                <a:gridCol w="2303011"/>
                <a:gridCol w="2571680"/>
              </a:tblGrid>
              <a:tr h="370840">
                <a:tc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800" b="1" dirty="0" smtClean="0"/>
                        <a:t>Succeed</a:t>
                      </a:r>
                      <a:r>
                        <a:rPr lang="en-US" altLang="zh-CN" sz="1800" b="1" baseline="0" dirty="0" smtClean="0"/>
                        <a:t> in</a:t>
                      </a:r>
                      <a:r>
                        <a:rPr lang="en-US" altLang="zh-CN" sz="1800" b="1" dirty="0" smtClean="0"/>
                        <a:t> Mating</a:t>
                      </a:r>
                      <a:endParaRPr lang="zh-CN" altLang="en-US" sz="1800" b="1" dirty="0"/>
                    </a:p>
                  </a:txBody>
                  <a:tcPr marL="57972" marR="57972" marT="28986" marB="28986"/>
                </a:tc>
                <a:tc>
                  <a:txBody>
                    <a:bodyPr/>
                    <a:lstStyle/>
                    <a:p>
                      <a:r>
                        <a:rPr lang="en-US" altLang="zh-CN" sz="1800" b="1" dirty="0" smtClean="0"/>
                        <a:t>Not</a:t>
                      </a:r>
                      <a:r>
                        <a:rPr lang="en-US" altLang="zh-CN" sz="1800" b="1" baseline="0" dirty="0" smtClean="0"/>
                        <a:t> S</a:t>
                      </a:r>
                      <a:r>
                        <a:rPr lang="en-US" altLang="zh-CN" sz="1800" b="1" dirty="0" smtClean="0"/>
                        <a:t>ucceed in Mating</a:t>
                      </a:r>
                      <a:endParaRPr lang="zh-CN" altLang="en-US" sz="1800" b="1" dirty="0"/>
                    </a:p>
                  </a:txBody>
                  <a:tcPr marL="57972" marR="57972" marT="28986" marB="28986"/>
                </a:tc>
                <a:tc>
                  <a:txBody>
                    <a:bodyPr/>
                    <a:lstStyle/>
                    <a:p>
                      <a:r>
                        <a:rPr lang="en-US" altLang="zh-CN" sz="1800" b="1" i="1" dirty="0" smtClean="0"/>
                        <a:t>P</a:t>
                      </a:r>
                      <a:r>
                        <a:rPr lang="en-US" altLang="zh-CN" sz="1800" b="1" i="0" baseline="0" dirty="0" smtClean="0"/>
                        <a:t>-</a:t>
                      </a:r>
                      <a:r>
                        <a:rPr lang="en-US" altLang="zh-CN" sz="1800" b="1" dirty="0" smtClean="0"/>
                        <a:t>value of Chi-square test</a:t>
                      </a:r>
                      <a:endParaRPr lang="zh-CN" altLang="en-US" sz="1800" b="1" dirty="0"/>
                    </a:p>
                  </a:txBody>
                  <a:tcPr marL="57972" marR="57972" marT="28986" marB="28986"/>
                </a:tc>
              </a:tr>
              <a:tr h="370840">
                <a:tc gridSpan="4">
                  <a:txBody>
                    <a:bodyPr/>
                    <a:lstStyle/>
                    <a:p>
                      <a:r>
                        <a:rPr lang="en-US" altLang="zh-CN" sz="1800" b="1" dirty="0" smtClean="0"/>
                        <a:t>Male Mating</a:t>
                      </a:r>
                      <a:r>
                        <a:rPr lang="en-US" altLang="zh-CN" sz="1800" b="1" baseline="0" dirty="0" smtClean="0"/>
                        <a:t> </a:t>
                      </a:r>
                      <a:r>
                        <a:rPr lang="en-US" altLang="zh-CN" sz="1800" b="1" dirty="0" smtClean="0"/>
                        <a:t>ability</a:t>
                      </a:r>
                      <a:endParaRPr lang="zh-CN" altLang="en-US" sz="1800" b="1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Control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40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0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i="1" dirty="0" smtClean="0"/>
                        <a:t>mir-977</a:t>
                      </a:r>
                      <a:r>
                        <a:rPr lang="en-US" altLang="zh-CN" dirty="0" smtClean="0"/>
                        <a:t> </a:t>
                      </a:r>
                      <a:r>
                        <a:rPr lang="en-US" altLang="zh-CN" dirty="0" smtClean="0"/>
                        <a:t>KO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41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0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</a:tr>
              <a:tr h="370840">
                <a:tc gridSpan="4">
                  <a:txBody>
                    <a:bodyPr/>
                    <a:lstStyle/>
                    <a:p>
                      <a:r>
                        <a:rPr lang="en-US" altLang="zh-CN" sz="1800" b="1" dirty="0" smtClean="0"/>
                        <a:t>Female</a:t>
                      </a:r>
                      <a:r>
                        <a:rPr lang="en-US" altLang="zh-CN" sz="1800" b="1" baseline="0" dirty="0" smtClean="0"/>
                        <a:t> Receptivity</a:t>
                      </a:r>
                      <a:endParaRPr lang="zh-CN" altLang="en-US" sz="1800" b="1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Control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31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9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i="1" dirty="0" smtClean="0"/>
                        <a:t>mir-977</a:t>
                      </a:r>
                      <a:r>
                        <a:rPr lang="en-US" altLang="zh-CN" dirty="0" smtClean="0"/>
                        <a:t> </a:t>
                      </a:r>
                      <a:r>
                        <a:rPr lang="en-US" altLang="zh-CN" dirty="0" smtClean="0"/>
                        <a:t>KO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23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18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0.04</a:t>
                      </a:r>
                      <a:endParaRPr lang="zh-CN" altLang="en-US" dirty="0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5679355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321263" y="738379"/>
            <a:ext cx="35725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8.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s used in this study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51148900"/>
              </p:ext>
            </p:extLst>
          </p:nvPr>
        </p:nvGraphicFramePr>
        <p:xfrm>
          <a:off x="398175" y="1236136"/>
          <a:ext cx="9756649" cy="311404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815656"/>
                <a:gridCol w="3814064"/>
                <a:gridCol w="4126929"/>
              </a:tblGrid>
              <a:tr h="370840"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Genes 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rimer pair used for mutant detecting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Primer pair used for </a:t>
                      </a:r>
                      <a:r>
                        <a:rPr lang="en-US" altLang="zh-CN" dirty="0" err="1" smtClean="0"/>
                        <a:t>qRT</a:t>
                      </a:r>
                      <a:r>
                        <a:rPr lang="en-US" altLang="zh-CN" dirty="0" smtClean="0"/>
                        <a:t>-PCR</a:t>
                      </a:r>
                      <a:endParaRPr lang="zh-CN" altLang="en-US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sz="18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iR-977-5p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F:AGCGGAGAATACGAAAGTGC</a:t>
                      </a:r>
                    </a:p>
                    <a:p>
                      <a:r>
                        <a:rPr lang="en-US" altLang="zh-CN" dirty="0" smtClean="0"/>
                        <a:t>R:TCTGATAGGGAAGGCACTC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RT: GTTGGCTCTGGTGCAGGGTCCGAGGTAT</a:t>
                      </a:r>
                    </a:p>
                    <a:p>
                      <a:r>
                        <a:rPr lang="en-US" altLang="zh-CN" dirty="0" smtClean="0"/>
                        <a:t>TCGCACCAGAGCCAACTTAGAC</a:t>
                      </a:r>
                    </a:p>
                    <a:p>
                      <a:r>
                        <a:rPr lang="en-US" altLang="zh-CN" dirty="0" smtClean="0"/>
                        <a:t>F: GGCGTGAGATATTCACGTT</a:t>
                      </a: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sz="18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iR-975-5p</a:t>
                      </a:r>
                    </a:p>
                    <a:p>
                      <a:r>
                        <a:rPr lang="en-US" altLang="zh-CN" dirty="0" smtClean="0"/>
                        <a:t>(Positive control)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F:AATACGAAAGTGCGGACCAC</a:t>
                      </a:r>
                    </a:p>
                    <a:p>
                      <a:r>
                        <a:rPr lang="en-US" altLang="zh-CN" dirty="0" smtClean="0"/>
                        <a:t>R:TCTGATAGGGAAGGCACTC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RT:GTTGGCTCTGGTGCAGGGTCCGAGGTATTCGCACCAGAGCCAACATACAGG</a:t>
                      </a:r>
                    </a:p>
                    <a:p>
                      <a:r>
                        <a:rPr lang="en-US" altLang="zh-CN" dirty="0" smtClean="0"/>
                        <a:t>F: GGCGTAAACACTTCCTACAT</a:t>
                      </a: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2s</a:t>
                      </a:r>
                    </a:p>
                    <a:p>
                      <a:r>
                        <a:rPr lang="en-US" altLang="zh-CN" dirty="0" smtClean="0"/>
                        <a:t>(Reference gene)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N.A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RT:GTTGGCTCTGGTGCAGGGTCCGAGGTATTCGCACCAGAGCCAACTACAAC</a:t>
                      </a:r>
                    </a:p>
                    <a:p>
                      <a:r>
                        <a:rPr lang="en-US" altLang="zh-CN" dirty="0" smtClean="0"/>
                        <a:t>F:GGCGTGCTTGGACTACATATGG</a:t>
                      </a:r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6" name="文本框 5"/>
          <p:cNvSpPr txBox="1"/>
          <p:nvPr/>
        </p:nvSpPr>
        <p:spPr>
          <a:xfrm>
            <a:off x="321263" y="4478601"/>
            <a:ext cx="67962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te: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Universal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vers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mer for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PCR is</a:t>
            </a:r>
            <a:r>
              <a:rPr lang="en-US" altLang="zh-CN" dirty="0" smtClean="0"/>
              <a:t>: GTGCAGGGTCCGAGGT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53375786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6"/>
          <p:cNvSpPr txBox="1"/>
          <p:nvPr/>
        </p:nvSpPr>
        <p:spPr>
          <a:xfrm>
            <a:off x="284899" y="546400"/>
            <a:ext cx="43128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S9.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LEN pairs design for </a:t>
            </a:r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-977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01169079"/>
              </p:ext>
            </p:extLst>
          </p:nvPr>
        </p:nvGraphicFramePr>
        <p:xfrm>
          <a:off x="375216" y="1063696"/>
          <a:ext cx="8913639" cy="74168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063943"/>
                <a:gridCol w="7849696"/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miRNA 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TALEN binding sites design for miRNA </a:t>
                      </a:r>
                      <a:endParaRPr lang="zh-CN" altLang="en-US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i="1" dirty="0" smtClean="0"/>
                        <a:t>mir-977</a:t>
                      </a:r>
                      <a:r>
                        <a:rPr lang="en-US" altLang="zh-CN" dirty="0" smtClean="0"/>
                        <a:t> 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T  </a:t>
                      </a:r>
                      <a:r>
                        <a:rPr lang="en-US" altLang="zh-CN" u="sng" dirty="0" smtClean="0"/>
                        <a:t>TCAGTGTTCGAAATCT</a:t>
                      </a:r>
                      <a:r>
                        <a:rPr lang="en-US" altLang="zh-CN" dirty="0" smtClean="0"/>
                        <a:t>GA</a:t>
                      </a:r>
                      <a:r>
                        <a:rPr lang="en-US" altLang="zh-CN" dirty="0" smtClean="0">
                          <a:solidFill>
                            <a:srgbClr val="FF0000"/>
                          </a:solidFill>
                        </a:rPr>
                        <a:t>TGAGATATTCACGTTGTCT  AA</a:t>
                      </a:r>
                      <a:r>
                        <a:rPr lang="en-US" altLang="zh-CN" u="sng" dirty="0" smtClean="0"/>
                        <a:t>ATCATGTTTTGTACG</a:t>
                      </a:r>
                      <a:r>
                        <a:rPr lang="en-US" altLang="zh-CN" dirty="0" smtClean="0"/>
                        <a:t>  A </a:t>
                      </a:r>
                      <a:endParaRPr lang="zh-CN" altLang="en-US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6" name="矩形 5"/>
          <p:cNvSpPr/>
          <p:nvPr/>
        </p:nvSpPr>
        <p:spPr>
          <a:xfrm>
            <a:off x="284899" y="2023404"/>
            <a:ext cx="1148460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e: For th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sign of TALEN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nding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tes ,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ture miRNA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uence is highlighted in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, </a:t>
            </a:r>
            <a:endParaRPr lang="en-US" altLang="zh-CN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LEN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nding sites are underlined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5490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矩形 5"/>
          <p:cNvSpPr/>
          <p:nvPr/>
        </p:nvSpPr>
        <p:spPr>
          <a:xfrm>
            <a:off x="350197" y="5131484"/>
            <a:ext cx="8928726" cy="113877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Independent deletion confirms male fertility increase due to </a:t>
            </a:r>
            <a:r>
              <a:rPr lang="en-US" altLang="zh-CN" b="1" i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-977</a:t>
            </a:r>
            <a:r>
              <a:rPr lang="en-US" altLang="zh-CN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letion.</a:t>
            </a:r>
          </a:p>
          <a:p>
            <a:pPr algn="just">
              <a:spcAft>
                <a:spcPts val="0"/>
              </a:spcAft>
            </a:pP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) Verification of an independent </a:t>
            </a:r>
            <a:r>
              <a:rPr lang="en-US" altLang="zh-CN" i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-977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ruption (</a:t>
            </a:r>
            <a:r>
              <a:rPr lang="en-US" altLang="zh-CN" i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-977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O-2).</a:t>
            </a:r>
          </a:p>
          <a:p>
            <a:pPr algn="just">
              <a:spcAft>
                <a:spcPts val="0"/>
              </a:spcAft>
            </a:pP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) Male fertility increase in </a:t>
            </a:r>
            <a:r>
              <a:rPr lang="en-US" altLang="zh-CN" i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-977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O-2 mutants. </a:t>
            </a:r>
          </a:p>
          <a:p>
            <a:pPr algn="just">
              <a:spcAft>
                <a:spcPts val="0"/>
              </a:spcAft>
            </a:pPr>
            <a:endParaRPr lang="zh-CN" altLang="zh-CN" sz="1400" b="1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0197" y="802949"/>
            <a:ext cx="7462151" cy="43285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315330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09525" y="6170089"/>
            <a:ext cx="3463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 . Lifecycle of new gene.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41249" y="211254"/>
            <a:ext cx="8492612" cy="59588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17336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188325" y="794332"/>
            <a:ext cx="5104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S1. </a:t>
            </a:r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-977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osophila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ecies.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表格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12950107"/>
              </p:ext>
            </p:extLst>
          </p:nvPr>
        </p:nvGraphicFramePr>
        <p:xfrm>
          <a:off x="351403" y="1242689"/>
          <a:ext cx="9134729" cy="111252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2632329"/>
                <a:gridCol w="1625600"/>
                <a:gridCol w="1625600"/>
                <a:gridCol w="1625600"/>
                <a:gridCol w="1625600"/>
              </a:tblGrid>
              <a:tr h="370840">
                <a:tc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i="1" dirty="0" err="1" smtClean="0"/>
                        <a:t>D.mel</a:t>
                      </a:r>
                      <a:endParaRPr lang="zh-CN" altLang="en-US" i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i="1" dirty="0" err="1" smtClean="0"/>
                        <a:t>D.sim</a:t>
                      </a:r>
                      <a:endParaRPr lang="zh-CN" altLang="en-US" i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i="1" dirty="0" err="1" smtClean="0"/>
                        <a:t>D.ere</a:t>
                      </a:r>
                      <a:endParaRPr lang="zh-CN" altLang="en-US" i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i="1" dirty="0" err="1" smtClean="0"/>
                        <a:t>D.vir</a:t>
                      </a:r>
                      <a:endParaRPr lang="zh-CN" altLang="en-US" i="1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Small RNA library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8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SM909277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8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SM1165053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8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SM1357621 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8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SM5486109 </a:t>
                      </a:r>
                      <a:endParaRPr lang="zh-CN" altLang="en-US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i="1" dirty="0" smtClean="0"/>
                        <a:t>mir-977</a:t>
                      </a:r>
                      <a:r>
                        <a:rPr lang="en-US" altLang="zh-CN" dirty="0" smtClean="0"/>
                        <a:t> </a:t>
                      </a:r>
                      <a:r>
                        <a:rPr lang="en-US" altLang="zh-CN" dirty="0" smtClean="0"/>
                        <a:t>expression(RPM)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7421.3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480.2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1.7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1435.11</a:t>
                      </a: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243016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表格 5"/>
          <p:cNvGraphicFramePr>
            <a:graphicFrameLocks noGrp="1"/>
          </p:cNvGraphicFramePr>
          <p:nvPr>
            <p:extLst/>
          </p:nvPr>
        </p:nvGraphicFramePr>
        <p:xfrm>
          <a:off x="446887" y="1087642"/>
          <a:ext cx="10400347" cy="3217344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577362"/>
                <a:gridCol w="2000160"/>
                <a:gridCol w="1138302"/>
                <a:gridCol w="1252132"/>
                <a:gridCol w="1024472"/>
                <a:gridCol w="1138302"/>
                <a:gridCol w="2269617"/>
              </a:tblGrid>
              <a:tr h="40216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 err="1">
                          <a:effectLst/>
                        </a:rPr>
                        <a:t>miRNA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 smtClean="0">
                          <a:effectLst/>
                        </a:rPr>
                        <a:t>Normalized</a:t>
                      </a:r>
                      <a:r>
                        <a:rPr lang="en-US" sz="1800" b="1" u="none" strike="noStrike" baseline="0" dirty="0" smtClean="0">
                          <a:effectLst/>
                        </a:rPr>
                        <a:t> expression(log2(RPM)) in different </a:t>
                      </a:r>
                      <a:r>
                        <a:rPr lang="en-US" sz="1800" b="1" u="none" strike="noStrike" dirty="0" smtClean="0">
                          <a:effectLst/>
                        </a:rPr>
                        <a:t>Genetic </a:t>
                      </a:r>
                      <a:r>
                        <a:rPr lang="en-US" sz="1800" b="1" u="none" strike="noStrike" dirty="0">
                          <a:effectLst/>
                        </a:rPr>
                        <a:t>Background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zh-CN" alt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l" fontAlgn="ctr"/>
                      <a:endParaRPr lang="zh-CN" alt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l" fontAlgn="ctr"/>
                      <a:endParaRPr lang="zh-CN" alt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l" fontAlgn="ctr"/>
                      <a:endParaRPr lang="zh-CN" alt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800" b="1" i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oefficient of Variation</a:t>
                      </a:r>
                      <a:r>
                        <a:rPr lang="zh-CN" altLang="en-US" sz="1800" b="1" i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（</a:t>
                      </a:r>
                      <a:r>
                        <a:rPr lang="en-US" altLang="zh-CN" sz="1800" b="1" i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%</a:t>
                      </a:r>
                      <a:r>
                        <a:rPr lang="zh-CN" altLang="en-US" sz="1800" b="1" i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）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402168">
                <a:tc vMerge="1">
                  <a:txBody>
                    <a:bodyPr/>
                    <a:lstStyle/>
                    <a:p>
                      <a:pPr algn="l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 smtClean="0">
                          <a:effectLst/>
                        </a:rPr>
                        <a:t>Oregon </a:t>
                      </a:r>
                      <a:r>
                        <a:rPr lang="en-US" sz="1600" u="none" strike="noStrike" dirty="0">
                          <a:effectLst/>
                        </a:rPr>
                        <a:t>R-1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 smtClean="0">
                          <a:effectLst/>
                        </a:rPr>
                        <a:t>Oregon </a:t>
                      </a:r>
                      <a:r>
                        <a:rPr lang="en-US" sz="1600" u="none" strike="noStrike" dirty="0">
                          <a:effectLst/>
                        </a:rPr>
                        <a:t>R-2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 err="1">
                          <a:effectLst/>
                        </a:rPr>
                        <a:t>hs</a:t>
                      </a:r>
                      <a:r>
                        <a:rPr lang="en-US" sz="1600" u="none" strike="noStrike" dirty="0">
                          <a:effectLst/>
                        </a:rPr>
                        <a:t>-Penelope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</a:rPr>
                        <a:t>A1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</a:rPr>
                        <a:t>yw67c23(2)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</a:tr>
              <a:tr h="4021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u="none" strike="noStrike" dirty="0">
                          <a:effectLst/>
                        </a:rPr>
                        <a:t>dme-let-7-5p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</a:rPr>
                        <a:t>15.29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</a:rPr>
                        <a:t>15.79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4.56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4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</a:rPr>
                        <a:t>14.89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 smtClean="0">
                          <a:effectLst/>
                        </a:rPr>
                        <a:t>4.1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4021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u="none" strike="noStrike">
                          <a:effectLst/>
                        </a:rPr>
                        <a:t>dme-miR-1-3p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</a:rPr>
                        <a:t>13.69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</a:rPr>
                        <a:t>13.99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</a:rPr>
                        <a:t>14.78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</a:rPr>
                        <a:t>14.34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4.42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</a:rPr>
                        <a:t>2.64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4021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u="none" strike="noStrike">
                          <a:effectLst/>
                        </a:rPr>
                        <a:t>dme-miR-34-5p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</a:rPr>
                        <a:t>14.97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6.74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</a:rPr>
                        <a:t>17.01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6.67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6.26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</a:rPr>
                        <a:t>4.4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4021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u="none" strike="noStrike">
                          <a:effectLst/>
                        </a:rPr>
                        <a:t>dme-bantam-3p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</a:rPr>
                        <a:t>17.12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6.62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</a:rPr>
                        <a:t>16.71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</a:rPr>
                        <a:t>16.19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6.57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</a:rPr>
                        <a:t>1.78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4021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u="none" strike="noStrike">
                          <a:effectLst/>
                        </a:rPr>
                        <a:t>dme-miR-184-3p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3.3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2.87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4.36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</a:rPr>
                        <a:t>13.74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3.9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</a:rPr>
                        <a:t>3.75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4021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dme-miR-977-3p</a:t>
                      </a:r>
                      <a:endParaRPr lang="en-US" sz="16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</a:rPr>
                        <a:t>12.87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2.25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0.16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</a:rPr>
                        <a:t>10.86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</a:rPr>
                        <a:t>10.69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</a:rPr>
                        <a:t>9.01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7" name="文本框 6"/>
          <p:cNvSpPr txBox="1"/>
          <p:nvPr/>
        </p:nvSpPr>
        <p:spPr>
          <a:xfrm>
            <a:off x="325384" y="538207"/>
            <a:ext cx="81657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variation of </a:t>
            </a:r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-977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testes across 5 lines of </a:t>
            </a:r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. melanogaster.</a:t>
            </a:r>
            <a:endParaRPr lang="zh-CN" altLang="en-US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325384" y="4440527"/>
            <a:ext cx="1056808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te: Compared to other conserved miRNAs that have important developmental function, </a:t>
            </a:r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-977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as higher </a:t>
            </a:r>
          </a:p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variation in the testes of multiple </a:t>
            </a:r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. melanogaster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es.  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935468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188325" y="791178"/>
            <a:ext cx="39209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le fertility of </a:t>
            </a:r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-977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O.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表格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51947416"/>
              </p:ext>
            </p:extLst>
          </p:nvPr>
        </p:nvGraphicFramePr>
        <p:xfrm>
          <a:off x="351403" y="1269339"/>
          <a:ext cx="9525869" cy="185420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508697"/>
                <a:gridCol w="3142481"/>
                <a:gridCol w="2303011"/>
                <a:gridCol w="2571680"/>
              </a:tblGrid>
              <a:tr h="370840">
                <a:tc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800" b="1" dirty="0" smtClean="0"/>
                        <a:t>Mean ± SEM</a:t>
                      </a:r>
                      <a:endParaRPr lang="zh-CN" altLang="en-US" sz="1800" b="1" dirty="0"/>
                    </a:p>
                  </a:txBody>
                  <a:tcPr marL="57972" marR="57972" marT="28986" marB="2898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800" b="1" dirty="0" smtClean="0"/>
                        <a:t>Sample</a:t>
                      </a:r>
                      <a:r>
                        <a:rPr lang="en-US" altLang="zh-CN" sz="1800" b="1" baseline="0" dirty="0" smtClean="0"/>
                        <a:t> size</a:t>
                      </a:r>
                      <a:endParaRPr lang="zh-CN" altLang="en-US" sz="1800" b="1" dirty="0"/>
                    </a:p>
                  </a:txBody>
                  <a:tcPr marL="57972" marR="57972" marT="28986" marB="2898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800" b="1" i="1" dirty="0" smtClean="0"/>
                        <a:t>P</a:t>
                      </a:r>
                      <a:r>
                        <a:rPr lang="en-US" altLang="zh-CN" sz="1800" b="1" i="0" baseline="0" dirty="0" smtClean="0"/>
                        <a:t>-</a:t>
                      </a:r>
                      <a:r>
                        <a:rPr lang="en-US" altLang="zh-CN" sz="1800" b="1" dirty="0" smtClean="0"/>
                        <a:t>value of </a:t>
                      </a:r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tudent's</a:t>
                      </a:r>
                      <a:r>
                        <a:rPr lang="en-US" altLang="zh-CN" sz="1800" b="1" i="1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t</a:t>
                      </a:r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test</a:t>
                      </a:r>
                      <a:endParaRPr lang="zh-CN" altLang="en-US" sz="1800" b="1" dirty="0"/>
                    </a:p>
                  </a:txBody>
                  <a:tcPr marL="57972" marR="57972" marT="28986" marB="28986"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Control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110±7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15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i="1" dirty="0" smtClean="0"/>
                        <a:t>mir-977</a:t>
                      </a:r>
                      <a:r>
                        <a:rPr lang="en-US" altLang="zh-CN" dirty="0" smtClean="0"/>
                        <a:t> </a:t>
                      </a:r>
                      <a:r>
                        <a:rPr lang="en-US" altLang="zh-CN" dirty="0" smtClean="0"/>
                        <a:t>KO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dirty="0" smtClean="0"/>
                        <a:t>158±11.5</a:t>
                      </a:r>
                      <a:endParaRPr lang="zh-CN" altLang="en-US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15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0.001</a:t>
                      </a:r>
                      <a:endParaRPr lang="zh-CN" altLang="en-US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dirty="0" smtClean="0"/>
                        <a:t>Control-2</a:t>
                      </a:r>
                      <a:endParaRPr lang="zh-CN" altLang="en-US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dirty="0" smtClean="0"/>
                        <a:t>84.8±4.6</a:t>
                      </a:r>
                      <a:endParaRPr lang="zh-CN" altLang="en-US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18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i="1" dirty="0" smtClean="0"/>
                        <a:t>mir-977</a:t>
                      </a:r>
                      <a:r>
                        <a:rPr lang="en-US" altLang="zh-CN" dirty="0" smtClean="0"/>
                        <a:t> </a:t>
                      </a:r>
                      <a:r>
                        <a:rPr lang="en-US" altLang="zh-CN" dirty="0" smtClean="0"/>
                        <a:t>KO-2</a:t>
                      </a:r>
                      <a:endParaRPr lang="zh-CN" altLang="en-US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dirty="0" smtClean="0"/>
                        <a:t>114.8±7.2</a:t>
                      </a:r>
                      <a:endParaRPr lang="zh-CN" altLang="en-US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15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0.001</a:t>
                      </a:r>
                      <a:endParaRPr lang="zh-CN" altLang="en-US" dirty="0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4328058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188325" y="791178"/>
            <a:ext cx="64665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.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imulating ovulation and sperm quality of </a:t>
            </a:r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-977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O.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表格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01188861"/>
              </p:ext>
            </p:extLst>
          </p:nvPr>
        </p:nvGraphicFramePr>
        <p:xfrm>
          <a:off x="351403" y="1269339"/>
          <a:ext cx="9525869" cy="2682175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508697"/>
                <a:gridCol w="3142481"/>
                <a:gridCol w="2303011"/>
                <a:gridCol w="2571680"/>
              </a:tblGrid>
              <a:tr h="370840">
                <a:tc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800" b="1" dirty="0" smtClean="0"/>
                        <a:t>Mean ± SEM</a:t>
                      </a:r>
                      <a:endParaRPr lang="zh-CN" altLang="en-US" sz="1800" b="1" dirty="0"/>
                    </a:p>
                  </a:txBody>
                  <a:tcPr marL="57972" marR="57972" marT="28986" marB="2898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800" b="1" dirty="0" smtClean="0"/>
                        <a:t>Sample</a:t>
                      </a:r>
                      <a:r>
                        <a:rPr lang="en-US" altLang="zh-CN" sz="1800" b="1" baseline="0" dirty="0" smtClean="0"/>
                        <a:t> size</a:t>
                      </a:r>
                      <a:endParaRPr lang="zh-CN" altLang="en-US" sz="1800" b="1" dirty="0"/>
                    </a:p>
                  </a:txBody>
                  <a:tcPr marL="57972" marR="57972" marT="28986" marB="2898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800" b="1" i="1" dirty="0" smtClean="0"/>
                        <a:t>P</a:t>
                      </a:r>
                      <a:r>
                        <a:rPr lang="en-US" altLang="zh-CN" sz="1800" b="1" i="0" baseline="0" dirty="0" smtClean="0"/>
                        <a:t>-</a:t>
                      </a:r>
                      <a:r>
                        <a:rPr lang="en-US" altLang="zh-CN" sz="1800" b="1" dirty="0" smtClean="0"/>
                        <a:t>value</a:t>
                      </a:r>
                      <a:endParaRPr lang="zh-CN" altLang="en-US" sz="1800" b="1" dirty="0"/>
                    </a:p>
                  </a:txBody>
                  <a:tcPr marL="57972" marR="57972" marT="28986" marB="28986"/>
                </a:tc>
              </a:tr>
              <a:tr h="449878">
                <a:tc gridSpan="4">
                  <a:txBody>
                    <a:bodyPr/>
                    <a:lstStyle/>
                    <a:p>
                      <a:r>
                        <a:rPr lang="en-US" altLang="zh-CN" b="1" dirty="0" smtClean="0"/>
                        <a:t>Stimulating ovulation (No. of eggs/mating )</a:t>
                      </a:r>
                      <a:endParaRPr lang="zh-CN" altLang="en-US" b="1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Control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34.4±3.6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16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i="1" dirty="0" smtClean="0"/>
                        <a:t>mir-977</a:t>
                      </a:r>
                      <a:r>
                        <a:rPr lang="en-US" altLang="zh-CN" dirty="0" smtClean="0"/>
                        <a:t> </a:t>
                      </a:r>
                      <a:r>
                        <a:rPr lang="en-US" altLang="zh-CN" dirty="0" smtClean="0"/>
                        <a:t>KO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dirty="0" smtClean="0"/>
                        <a:t>47.6±5.3</a:t>
                      </a:r>
                      <a:endParaRPr lang="zh-CN" altLang="en-US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12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0.04</a:t>
                      </a:r>
                      <a:r>
                        <a:rPr lang="en-US" altLang="zh-CN" baseline="30000" dirty="0" smtClean="0"/>
                        <a:t>a</a:t>
                      </a:r>
                      <a:endParaRPr lang="zh-CN" altLang="en-US" baseline="30000" dirty="0"/>
                    </a:p>
                  </a:txBody>
                  <a:tcPr/>
                </a:tc>
              </a:tr>
              <a:tr h="370840">
                <a:tc gridSpan="4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b="1" dirty="0" smtClean="0"/>
                        <a:t>Sperm</a:t>
                      </a:r>
                      <a:r>
                        <a:rPr lang="en-US" altLang="zh-CN" b="1" baseline="0" dirty="0" smtClean="0"/>
                        <a:t> quality </a:t>
                      </a:r>
                      <a:r>
                        <a:rPr lang="en-US" altLang="zh-CN" b="1" dirty="0" smtClean="0"/>
                        <a:t>(Egg</a:t>
                      </a:r>
                      <a:r>
                        <a:rPr lang="en-US" altLang="zh-CN" b="1" baseline="0" dirty="0" smtClean="0"/>
                        <a:t> hatchability</a:t>
                      </a:r>
                      <a:r>
                        <a:rPr lang="en-US" altLang="zh-CN" b="1" dirty="0" smtClean="0"/>
                        <a:t>)</a:t>
                      </a:r>
                      <a:endParaRPr lang="zh-CN" altLang="en-US" b="1" dirty="0" smtClean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dirty="0" smtClean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dirty="0" smtClean="0"/>
                        <a:t>Control</a:t>
                      </a:r>
                      <a:endParaRPr lang="zh-CN" altLang="en-US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dirty="0" smtClean="0"/>
                        <a:t>0.85±0.03</a:t>
                      </a:r>
                      <a:endParaRPr lang="zh-CN" altLang="en-US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16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</a:tr>
              <a:tr h="37809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i="1" dirty="0" smtClean="0"/>
                        <a:t>mir-977</a:t>
                      </a:r>
                      <a:r>
                        <a:rPr lang="en-US" altLang="zh-CN" dirty="0" smtClean="0"/>
                        <a:t> </a:t>
                      </a:r>
                      <a:r>
                        <a:rPr lang="en-US" altLang="zh-CN" dirty="0" smtClean="0"/>
                        <a:t>KO</a:t>
                      </a:r>
                      <a:endParaRPr lang="zh-CN" altLang="en-US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dirty="0" smtClean="0"/>
                        <a:t>0.83±0.05</a:t>
                      </a:r>
                      <a:endParaRPr lang="zh-CN" altLang="en-US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12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0.74</a:t>
                      </a:r>
                      <a:r>
                        <a:rPr lang="en-US" altLang="zh-CN" baseline="30000" dirty="0" smtClean="0"/>
                        <a:t>b</a:t>
                      </a:r>
                      <a:endParaRPr lang="zh-CN" altLang="en-US" baseline="30000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2" name="文本框 1"/>
          <p:cNvSpPr txBox="1"/>
          <p:nvPr/>
        </p:nvSpPr>
        <p:spPr>
          <a:xfrm>
            <a:off x="351403" y="3944257"/>
            <a:ext cx="68958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Note: </a:t>
            </a:r>
            <a:r>
              <a:rPr lang="en-US" altLang="zh-CN" dirty="0" smtClean="0"/>
              <a:t>a, </a:t>
            </a:r>
            <a:r>
              <a:rPr lang="en-US" altLang="zh-CN" i="1" dirty="0" smtClean="0"/>
              <a:t>P</a:t>
            </a:r>
            <a:r>
              <a:rPr lang="en-US" altLang="zh-CN" dirty="0" smtClean="0"/>
              <a:t>- value </a:t>
            </a:r>
            <a:r>
              <a:rPr lang="en-US" altLang="zh-CN" dirty="0"/>
              <a:t>of Student's </a:t>
            </a:r>
            <a:r>
              <a:rPr lang="en-US" altLang="zh-CN" i="1" dirty="0"/>
              <a:t>t</a:t>
            </a:r>
            <a:r>
              <a:rPr lang="en-US" altLang="zh-CN" dirty="0"/>
              <a:t> </a:t>
            </a:r>
            <a:r>
              <a:rPr lang="en-US" altLang="zh-CN" dirty="0" smtClean="0"/>
              <a:t>test;  b,</a:t>
            </a:r>
            <a:r>
              <a:rPr lang="en-US" altLang="zh-CN" i="1" dirty="0"/>
              <a:t> P</a:t>
            </a:r>
            <a:r>
              <a:rPr lang="en-US" altLang="zh-CN" dirty="0"/>
              <a:t>- value of </a:t>
            </a:r>
            <a:r>
              <a:rPr lang="en-US" altLang="zh-CN" dirty="0" smtClean="0"/>
              <a:t>Mann Whitney </a:t>
            </a:r>
            <a:r>
              <a:rPr lang="en-US" altLang="zh-CN" i="1" dirty="0" smtClean="0"/>
              <a:t>U</a:t>
            </a:r>
            <a:r>
              <a:rPr lang="en-US" altLang="zh-CN" dirty="0" smtClean="0"/>
              <a:t> </a:t>
            </a:r>
            <a:r>
              <a:rPr lang="en-US" altLang="zh-CN" dirty="0"/>
              <a:t>test</a:t>
            </a:r>
            <a:r>
              <a:rPr lang="en-US" altLang="zh-CN" dirty="0" smtClean="0"/>
              <a:t>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13291746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188325" y="791178"/>
            <a:ext cx="39465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.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iotic drive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-977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O.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82553036"/>
              </p:ext>
            </p:extLst>
          </p:nvPr>
        </p:nvGraphicFramePr>
        <p:xfrm>
          <a:off x="351403" y="1269339"/>
          <a:ext cx="9340131" cy="111252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322959"/>
                <a:gridCol w="3142481"/>
                <a:gridCol w="2303011"/>
                <a:gridCol w="2571680"/>
              </a:tblGrid>
              <a:tr h="370840">
                <a:tc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800" b="1" dirty="0" smtClean="0"/>
                        <a:t>Mean ± SEM</a:t>
                      </a:r>
                      <a:endParaRPr lang="zh-CN" altLang="en-US" sz="1800" b="1" dirty="0"/>
                    </a:p>
                  </a:txBody>
                  <a:tcPr marL="57972" marR="57972" marT="28986" marB="2898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800" b="1" dirty="0" smtClean="0"/>
                        <a:t>Sample</a:t>
                      </a:r>
                      <a:r>
                        <a:rPr lang="en-US" altLang="zh-CN" sz="1800" b="1" baseline="0" dirty="0" smtClean="0"/>
                        <a:t> size</a:t>
                      </a:r>
                      <a:endParaRPr lang="zh-CN" altLang="en-US" sz="1800" b="1" dirty="0"/>
                    </a:p>
                  </a:txBody>
                  <a:tcPr marL="57972" marR="57972" marT="28986" marB="2898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800" b="1" i="1" dirty="0" smtClean="0"/>
                        <a:t>P</a:t>
                      </a:r>
                      <a:r>
                        <a:rPr lang="en-US" altLang="zh-CN" sz="1800" b="1" i="0" baseline="0" dirty="0" smtClean="0"/>
                        <a:t>-</a:t>
                      </a:r>
                      <a:r>
                        <a:rPr lang="en-US" altLang="zh-CN" sz="1800" b="1" dirty="0" smtClean="0"/>
                        <a:t>value of </a:t>
                      </a:r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tudent's</a:t>
                      </a:r>
                      <a:r>
                        <a:rPr lang="en-US" altLang="zh-CN" sz="1800" b="1" i="1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t</a:t>
                      </a:r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test</a:t>
                      </a:r>
                      <a:endParaRPr lang="zh-CN" altLang="en-US" sz="1800" b="1" dirty="0"/>
                    </a:p>
                  </a:txBody>
                  <a:tcPr marL="57972" marR="57972" marT="28986" marB="28986"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Control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1.03±0.05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15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i="1" dirty="0" smtClean="0"/>
                        <a:t>mir-977</a:t>
                      </a:r>
                      <a:r>
                        <a:rPr lang="en-US" altLang="zh-CN" dirty="0" smtClean="0"/>
                        <a:t> </a:t>
                      </a:r>
                      <a:r>
                        <a:rPr lang="en-US" altLang="zh-CN" dirty="0" smtClean="0"/>
                        <a:t>KO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dirty="0" smtClean="0"/>
                        <a:t>1.07±0.06</a:t>
                      </a:r>
                      <a:endParaRPr lang="zh-CN" altLang="en-US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15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0.61</a:t>
                      </a:r>
                      <a:endParaRPr lang="zh-CN" altLang="en-US" dirty="0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6211926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188325" y="791178"/>
            <a:ext cx="34989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6.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ability of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977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O.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表格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62806967"/>
              </p:ext>
            </p:extLst>
          </p:nvPr>
        </p:nvGraphicFramePr>
        <p:xfrm>
          <a:off x="351403" y="1269339"/>
          <a:ext cx="9693848" cy="259588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322959"/>
                <a:gridCol w="1160780"/>
                <a:gridCol w="1476693"/>
                <a:gridCol w="698818"/>
                <a:gridCol w="1480947"/>
                <a:gridCol w="1673924"/>
                <a:gridCol w="1879727"/>
              </a:tblGrid>
              <a:tr h="370840">
                <a:tc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M/M or Y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FM7c/M or Y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Total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Survival ratio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Relative fitness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Binomial  </a:t>
                      </a:r>
                      <a:r>
                        <a:rPr lang="en-US" altLang="zh-CN" i="1" dirty="0" smtClean="0"/>
                        <a:t>P</a:t>
                      </a:r>
                      <a:r>
                        <a:rPr lang="en-US" altLang="zh-CN" dirty="0" smtClean="0"/>
                        <a:t>-value</a:t>
                      </a:r>
                      <a:endParaRPr lang="zh-CN" altLang="en-US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b="1" dirty="0" smtClean="0"/>
                        <a:t>Male</a:t>
                      </a:r>
                      <a:endParaRPr lang="zh-CN" altLang="en-US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i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i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Control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490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450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940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0.521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i="0" dirty="0" smtClean="0"/>
                        <a:t>1</a:t>
                      </a:r>
                      <a:endParaRPr lang="zh-CN" altLang="en-US" i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i="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i="1" dirty="0" smtClean="0"/>
                        <a:t>mir-977</a:t>
                      </a:r>
                      <a:r>
                        <a:rPr lang="en-US" altLang="zh-CN" dirty="0" smtClean="0"/>
                        <a:t> </a:t>
                      </a:r>
                      <a:r>
                        <a:rPr lang="en-US" altLang="zh-CN" dirty="0" smtClean="0"/>
                        <a:t>KO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455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360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815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0.558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i="0" dirty="0" smtClean="0"/>
                        <a:t>1.07</a:t>
                      </a:r>
                      <a:endParaRPr lang="zh-CN" altLang="en-US" i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i="0" dirty="0" smtClean="0"/>
                        <a:t>0.012</a:t>
                      </a:r>
                      <a:endParaRPr lang="zh-CN" altLang="en-US" i="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b="1" dirty="0" smtClean="0"/>
                        <a:t>Female</a:t>
                      </a:r>
                      <a:r>
                        <a:rPr lang="en-US" altLang="zh-CN" dirty="0" smtClean="0"/>
                        <a:t> 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i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i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Control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544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485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1092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0.528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i="0" dirty="0" smtClean="0"/>
                        <a:t>1</a:t>
                      </a:r>
                      <a:endParaRPr lang="zh-CN" altLang="en-US" i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i="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i="1" dirty="0" smtClean="0"/>
                        <a:t>mir-977</a:t>
                      </a:r>
                      <a:r>
                        <a:rPr lang="en-US" altLang="zh-CN" dirty="0" smtClean="0"/>
                        <a:t> </a:t>
                      </a:r>
                      <a:r>
                        <a:rPr lang="en-US" altLang="zh-CN" dirty="0" smtClean="0"/>
                        <a:t>KO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499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456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955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0.523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i="0" dirty="0" smtClean="0"/>
                        <a:t>0.991</a:t>
                      </a:r>
                      <a:endParaRPr lang="zh-CN" altLang="en-US" i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i="0" dirty="0" smtClean="0"/>
                        <a:t>0.48</a:t>
                      </a:r>
                      <a:endParaRPr lang="zh-CN" altLang="en-US" i="0" dirty="0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789498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47</TotalTime>
  <Words>658</Words>
  <Application>Microsoft Office PowerPoint</Application>
  <PresentationFormat>宽屏</PresentationFormat>
  <Paragraphs>222</Paragraphs>
  <Slides>12</Slides>
  <Notes>3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2</vt:i4>
      </vt:variant>
    </vt:vector>
  </HeadingPairs>
  <TitlesOfParts>
    <vt:vector size="18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微软中国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uGA</dc:creator>
  <cp:lastModifiedBy>LuGA</cp:lastModifiedBy>
  <cp:revision>43</cp:revision>
  <dcterms:created xsi:type="dcterms:W3CDTF">2017-11-17T10:23:42Z</dcterms:created>
  <dcterms:modified xsi:type="dcterms:W3CDTF">2018-04-28T09:47:02Z</dcterms:modified>
</cp:coreProperties>
</file>